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6858000" cy="9906000" type="A4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9" d="100"/>
          <a:sy n="79" d="100"/>
        </p:scale>
        <p:origin x="-3306" y="-27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05DC3-F086-4E4C-9856-BA2F9851D18F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6C41E-0C52-4EE9-9B3C-0519623EF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943618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05DC3-F086-4E4C-9856-BA2F9851D18F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6C41E-0C52-4EE9-9B3C-0519623EF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366743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7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05DC3-F086-4E4C-9856-BA2F9851D18F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6C41E-0C52-4EE9-9B3C-0519623EF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398561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05DC3-F086-4E4C-9856-BA2F9851D18F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6C41E-0C52-4EE9-9B3C-0519623EF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656766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9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05DC3-F086-4E4C-9856-BA2F9851D18F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6C41E-0C52-4EE9-9B3C-0519623EF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68948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3338692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3338692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05DC3-F086-4E4C-9856-BA2F9851D18F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6C41E-0C52-4EE9-9B3C-0519623EF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511289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05DC3-F086-4E4C-9856-BA2F9851D18F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6C41E-0C52-4EE9-9B3C-0519623EF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640818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05DC3-F086-4E4C-9856-BA2F9851D18F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6C41E-0C52-4EE9-9B3C-0519623EF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774022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05DC3-F086-4E4C-9856-BA2F9851D18F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6C41E-0C52-4EE9-9B3C-0519623EF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322329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9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05DC3-F086-4E4C-9856-BA2F9851D18F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6C41E-0C52-4EE9-9B3C-0519623EF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746306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05DC3-F086-4E4C-9856-BA2F9851D18F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6C41E-0C52-4EE9-9B3C-0519623EF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13916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205DC3-F086-4E4C-9856-BA2F9851D18F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E6C41E-0C52-4EE9-9B3C-0519623EF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587036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>
            <a:grpSpLocks noChangeAspect="1"/>
          </p:cNvGrpSpPr>
          <p:nvPr/>
        </p:nvGrpSpPr>
        <p:grpSpPr>
          <a:xfrm>
            <a:off x="556196" y="199693"/>
            <a:ext cx="5725234" cy="8600504"/>
            <a:chOff x="471972" y="426209"/>
            <a:chExt cx="5902836" cy="8867300"/>
          </a:xfrm>
        </p:grpSpPr>
        <p:grpSp>
          <p:nvGrpSpPr>
            <p:cNvPr id="12" name="Group 11"/>
            <p:cNvGrpSpPr>
              <a:grpSpLocks noChangeAspect="1"/>
            </p:cNvGrpSpPr>
            <p:nvPr/>
          </p:nvGrpSpPr>
          <p:grpSpPr>
            <a:xfrm>
              <a:off x="471972" y="426209"/>
              <a:ext cx="5832000" cy="8867300"/>
              <a:chOff x="266232" y="247569"/>
              <a:chExt cx="5976542" cy="9076880"/>
            </a:xfrm>
          </p:grpSpPr>
          <p:pic>
            <p:nvPicPr>
              <p:cNvPr id="4" name="Picture 5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219" t="14908" r="68915" b="9500"/>
              <a:stretch/>
            </p:blipFill>
            <p:spPr bwMode="auto">
              <a:xfrm>
                <a:off x="266232" y="247569"/>
                <a:ext cx="428263" cy="70596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238" t="69000" r="68899" b="9500"/>
              <a:stretch/>
            </p:blipFill>
            <p:spPr bwMode="auto">
              <a:xfrm>
                <a:off x="266377" y="7314421"/>
                <a:ext cx="428263" cy="20100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" name="Picture 5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551" t="14908" r="27396" b="9500"/>
              <a:stretch/>
            </p:blipFill>
            <p:spPr bwMode="auto">
              <a:xfrm>
                <a:off x="706070" y="254759"/>
                <a:ext cx="5536704" cy="70596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7" name="Picture 2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250" t="69000" r="27500" b="9500"/>
              <a:stretch/>
            </p:blipFill>
            <p:spPr bwMode="auto">
              <a:xfrm>
                <a:off x="808940" y="7314421"/>
                <a:ext cx="5422404" cy="20100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cxnSp>
          <p:nvCxnSpPr>
            <p:cNvPr id="36" name="Straight Connector 35"/>
            <p:cNvCxnSpPr/>
            <p:nvPr/>
          </p:nvCxnSpPr>
          <p:spPr>
            <a:xfrm>
              <a:off x="3272571" y="8263870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65"/>
            <p:cNvSpPr txBox="1"/>
            <p:nvPr/>
          </p:nvSpPr>
          <p:spPr>
            <a:xfrm>
              <a:off x="3253544" y="8201937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cxnSp>
          <p:nvCxnSpPr>
            <p:cNvPr id="15" name="Straight Connector 14"/>
            <p:cNvCxnSpPr/>
            <p:nvPr/>
          </p:nvCxnSpPr>
          <p:spPr>
            <a:xfrm>
              <a:off x="5714676" y="693005"/>
              <a:ext cx="28803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5400655" y="933035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5533428" y="1058350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5530138" y="1183886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5699647" y="1304959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5712928" y="1429454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>
              <a:off x="3277308" y="5686320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>
              <a:off x="3283886" y="5930225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>
              <a:off x="3283886" y="6054050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3280255" y="6179267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3277308" y="6301895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>
              <a:off x="3285727" y="5810100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>
              <a:off x="4484203" y="4591965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/>
          </p:nvCxnSpPr>
          <p:spPr>
            <a:xfrm>
              <a:off x="3824031" y="4839615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/>
          </p:nvCxnSpPr>
          <p:spPr>
            <a:xfrm>
              <a:off x="3814506" y="4965170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3813460" y="5087050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>
              <a:off x="3283114" y="7653761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/>
          </p:nvCxnSpPr>
          <p:spPr>
            <a:xfrm>
              <a:off x="3285922" y="7768574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/>
          </p:nvCxnSpPr>
          <p:spPr>
            <a:xfrm>
              <a:off x="3279344" y="7892399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3279344" y="8009646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>
              <a:off x="3279344" y="8133081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>
              <a:off x="3166500" y="7525730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/>
            <p:cNvSpPr txBox="1"/>
            <p:nvPr/>
          </p:nvSpPr>
          <p:spPr>
            <a:xfrm>
              <a:off x="2460119" y="1357200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703008" y="1357200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3126870" y="1357200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3250695" y="1357200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2762334" y="3308400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3014108" y="3308400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3367020" y="3308400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3253490" y="3308400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681923" y="3308400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4470594" y="3308400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4772447" y="3308400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5199475" y="3308400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5382284" y="3308400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5315949" y="3308400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2214922" y="4280400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2831784" y="4280400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1671997" y="5259600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975388" y="5259600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5803332" y="5259600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6042971" y="6224400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1362156" y="7200001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1549710" y="7200001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1914394" y="7200001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5258784" y="7200001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5804820" y="7200001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^</a:t>
              </a:r>
              <a:endParaRPr lang="en-AU" sz="1000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5992373" y="7200001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^</a:t>
              </a:r>
              <a:endParaRPr lang="en-AU" sz="1000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1603370" y="8197200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3611952" y="8197200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5317518" y="5259600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*</a:t>
              </a:r>
              <a:endParaRPr lang="en-AU" sz="1000" dirty="0"/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3007209" y="6221644"/>
              <a:ext cx="3318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 smtClean="0"/>
                <a:t>~</a:t>
              </a:r>
              <a:endParaRPr lang="en-AU" sz="1000" dirty="0"/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469232" y="8872390"/>
            <a:ext cx="581219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smtClean="0"/>
              <a:t>Figure. </a:t>
            </a:r>
            <a:r>
              <a:rPr lang="en-GB" sz="1000" b="1" dirty="0"/>
              <a:t>S3</a:t>
            </a:r>
            <a:r>
              <a:rPr lang="en-GB" sz="1000" dirty="0"/>
              <a:t>. </a:t>
            </a:r>
            <a:r>
              <a:rPr lang="en-GB" sz="1000" b="1" dirty="0"/>
              <a:t>Amino acid sequence alignment of glycoprotein </a:t>
            </a:r>
            <a:r>
              <a:rPr lang="en-GB" sz="1000" b="1" dirty="0" err="1"/>
              <a:t>Gc</a:t>
            </a:r>
            <a:r>
              <a:rPr lang="en-GB" sz="1000" b="1" dirty="0"/>
              <a:t> of the DGK group viruses and CCHFV.</a:t>
            </a:r>
            <a:r>
              <a:rPr lang="en-GB" sz="1000" dirty="0"/>
              <a:t> The </a:t>
            </a:r>
            <a:r>
              <a:rPr lang="en-GB" sz="1000" dirty="0" err="1"/>
              <a:t>Gc</a:t>
            </a:r>
            <a:r>
              <a:rPr lang="en-GB" sz="1000" dirty="0"/>
              <a:t> protein contains 28 cysteine residues (*) conserved amongst nairoviruses, with an additional two cysteine residues conserved in most nairovirus groups (^) and a third conserved amongst some of the nairovirus groups (~). Predicted glycosylation sites are underlined.</a:t>
            </a:r>
            <a:endParaRPr lang="en-AU" sz="1000" dirty="0"/>
          </a:p>
        </p:txBody>
      </p:sp>
    </p:spTree>
    <p:extLst>
      <p:ext uri="{BB962C8B-B14F-4D97-AF65-F5344CB8AC3E}">
        <p14:creationId xmlns:p14="http://schemas.microsoft.com/office/powerpoint/2010/main" val="1713515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1</TotalTime>
  <Words>91</Words>
  <Application>Microsoft Office PowerPoint</Application>
  <PresentationFormat>A4 Paper (210x297 mm)</PresentationFormat>
  <Paragraphs>3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DST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uci, Penny</dc:creator>
  <cp:lastModifiedBy>Gauci, Penny</cp:lastModifiedBy>
  <cp:revision>30</cp:revision>
  <cp:lastPrinted>2017-10-09T02:16:35Z</cp:lastPrinted>
  <dcterms:created xsi:type="dcterms:W3CDTF">2017-02-12T23:10:39Z</dcterms:created>
  <dcterms:modified xsi:type="dcterms:W3CDTF">2017-11-01T04:24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hecked by">
    <vt:lpwstr>32123</vt:lpwstr>
  </property>
  <property fmtid="{D5CDD505-2E9C-101B-9397-08002B2CF9AE}" pid="3" name="Objective-Id">
    <vt:lpwstr>AV15014918</vt:lpwstr>
  </property>
  <property fmtid="{D5CDD505-2E9C-101B-9397-08002B2CF9AE}" pid="4" name="Objective-Title">
    <vt:lpwstr>S3 Figure Gc</vt:lpwstr>
  </property>
  <property fmtid="{D5CDD505-2E9C-101B-9397-08002B2CF9AE}" pid="5" name="Objective-Comment">
    <vt:lpwstr>
    </vt:lpwstr>
  </property>
  <property fmtid="{D5CDD505-2E9C-101B-9397-08002B2CF9AE}" pid="6" name="Objective-CreationStamp">
    <vt:filetime>2017-07-31T22:23:13Z</vt:filetime>
  </property>
  <property fmtid="{D5CDD505-2E9C-101B-9397-08002B2CF9AE}" pid="7" name="Objective-IsApproved">
    <vt:bool>false</vt:bool>
  </property>
  <property fmtid="{D5CDD505-2E9C-101B-9397-08002B2CF9AE}" pid="8" name="Objective-IsPublished">
    <vt:bool>false</vt:bool>
  </property>
  <property fmtid="{D5CDD505-2E9C-101B-9397-08002B2CF9AE}" pid="9" name="Objective-DatePublished">
    <vt:lpwstr>
    </vt:lpwstr>
  </property>
  <property fmtid="{D5CDD505-2E9C-101B-9397-08002B2CF9AE}" pid="10" name="Objective-ModificationStamp">
    <vt:filetime>2017-07-31T22:23:43Z</vt:filetime>
  </property>
  <property fmtid="{D5CDD505-2E9C-101B-9397-08002B2CF9AE}" pid="11" name="Objective-Owner">
    <vt:lpwstr>Gauci, Penny (Ms)(DSTO)</vt:lpwstr>
  </property>
  <property fmtid="{D5CDD505-2E9C-101B-9397-08002B2CF9AE}" pid="12" name="Objective-Path">
    <vt:lpwstr>Objective Global Folder - PROD:Defence Business Units:Defence Science and Technology Group:LD : DSTG Land Division:17 MSTC C&amp;BD:Primary Outputs:Research Reports:Virology:Vinegar Hill virus paper:supplementary information:</vt:lpwstr>
  </property>
  <property fmtid="{D5CDD505-2E9C-101B-9397-08002B2CF9AE}" pid="13" name="Objective-Parent">
    <vt:lpwstr>supplementary information</vt:lpwstr>
  </property>
  <property fmtid="{D5CDD505-2E9C-101B-9397-08002B2CF9AE}" pid="14" name="Objective-State">
    <vt:lpwstr>Being Drafted</vt:lpwstr>
  </property>
  <property fmtid="{D5CDD505-2E9C-101B-9397-08002B2CF9AE}" pid="15" name="Objective-Version">
    <vt:lpwstr>0.1</vt:lpwstr>
  </property>
  <property fmtid="{D5CDD505-2E9C-101B-9397-08002B2CF9AE}" pid="16" name="Objective-VersionNumber">
    <vt:i4>1</vt:i4>
  </property>
  <property fmtid="{D5CDD505-2E9C-101B-9397-08002B2CF9AE}" pid="17" name="Objective-VersionComment">
    <vt:lpwstr>First version</vt:lpwstr>
  </property>
  <property fmtid="{D5CDD505-2E9C-101B-9397-08002B2CF9AE}" pid="18" name="Objective-FileNumber">
    <vt:lpwstr>
    </vt:lpwstr>
  </property>
  <property fmtid="{D5CDD505-2E9C-101B-9397-08002B2CF9AE}" pid="19" name="Objective-Classification">
    <vt:lpwstr>[Inherited - Unclassified]</vt:lpwstr>
  </property>
  <property fmtid="{D5CDD505-2E9C-101B-9397-08002B2CF9AE}" pid="20" name="Objective-Caveats">
    <vt:lpwstr>
    </vt:lpwstr>
  </property>
  <property fmtid="{D5CDD505-2E9C-101B-9397-08002B2CF9AE}" pid="21" name="Objective-Document Type [system]">
    <vt:lpwstr>
    </vt:lpwstr>
  </property>
</Properties>
</file>